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C0EAC-944F-4C9A-BEA4-B10C065AFA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1E53E-2854-4744-8CE7-1F64376E2B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423BD-C7E3-42A9-89C9-BC4DE5D681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FC169-E41E-44DD-AB07-33FDE540CB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0F73B-DC52-4108-8EE4-A08177D459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14681-30C6-4784-83A4-80819DCF23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42128-FECD-40C0-822E-BE68AB33E3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323BA-8F87-46A5-A546-6D7D683E24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4BF85-FA2C-4AAE-974C-DA54187270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F0157-17C8-4FD9-8F32-CC29C49BFA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3DAAA-1BDF-4A3E-8997-4460E27AC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2C1B5-08E8-41C7-A76D-7A5BBAEB0B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D8595F-8EC1-4A9F-871B-FBD31CEDFE1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762120" y="519120"/>
            <a:ext cx="4165560" cy="3327480"/>
          </a:xfrm>
          <a:prstGeom prst="rect">
            <a:avLst/>
          </a:prstGeom>
          <a:ln w="0">
            <a:noFill/>
          </a:ln>
        </p:spPr>
      </p:pic>
      <p:grpSp>
        <p:nvGrpSpPr>
          <p:cNvPr id="42" name="Group 20"/>
          <p:cNvGrpSpPr/>
          <p:nvPr/>
        </p:nvGrpSpPr>
        <p:grpSpPr>
          <a:xfrm>
            <a:off x="335160" y="3886200"/>
            <a:ext cx="6184800" cy="3427560"/>
            <a:chOff x="335160" y="3886200"/>
            <a:chExt cx="6184800" cy="3427560"/>
          </a:xfrm>
        </p:grpSpPr>
        <p:grpSp>
          <p:nvGrpSpPr>
            <p:cNvPr id="43" name="Group 10"/>
            <p:cNvGrpSpPr/>
            <p:nvPr/>
          </p:nvGrpSpPr>
          <p:grpSpPr>
            <a:xfrm>
              <a:off x="335160" y="3886200"/>
              <a:ext cx="6184800" cy="2872800"/>
              <a:chOff x="335160" y="3886200"/>
              <a:chExt cx="6184800" cy="2872800"/>
            </a:xfrm>
          </p:grpSpPr>
          <p:pic>
            <p:nvPicPr>
              <p:cNvPr id="44" name="Chart 11" descr=""/>
              <p:cNvPicPr/>
              <p:nvPr/>
            </p:nvPicPr>
            <p:blipFill>
              <a:blip r:embed="rId2"/>
              <a:stretch/>
            </p:blipFill>
            <p:spPr>
              <a:xfrm>
                <a:off x="493560" y="3886200"/>
                <a:ext cx="2059560" cy="150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Chart 12" descr=""/>
              <p:cNvPicPr/>
              <p:nvPr/>
            </p:nvPicPr>
            <p:blipFill>
              <a:blip r:embed="rId3"/>
              <a:stretch/>
            </p:blipFill>
            <p:spPr>
              <a:xfrm>
                <a:off x="2480040" y="3886200"/>
                <a:ext cx="2053440" cy="150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Chart 13" descr=""/>
              <p:cNvPicPr/>
              <p:nvPr/>
            </p:nvPicPr>
            <p:blipFill>
              <a:blip r:embed="rId4"/>
              <a:stretch/>
            </p:blipFill>
            <p:spPr>
              <a:xfrm>
                <a:off x="4454280" y="3886200"/>
                <a:ext cx="2059560" cy="150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Chart 14" descr=""/>
              <p:cNvPicPr/>
              <p:nvPr/>
            </p:nvPicPr>
            <p:blipFill>
              <a:blip r:embed="rId5"/>
              <a:stretch/>
            </p:blipFill>
            <p:spPr>
              <a:xfrm>
                <a:off x="493560" y="5258520"/>
                <a:ext cx="2053440" cy="150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Chart 15" descr=""/>
              <p:cNvPicPr/>
              <p:nvPr/>
            </p:nvPicPr>
            <p:blipFill>
              <a:blip r:embed="rId6"/>
              <a:stretch/>
            </p:blipFill>
            <p:spPr>
              <a:xfrm>
                <a:off x="2473920" y="5258520"/>
                <a:ext cx="2059560" cy="150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Chart 16" descr=""/>
              <p:cNvPicPr/>
              <p:nvPr/>
            </p:nvPicPr>
            <p:blipFill>
              <a:blip r:embed="rId7"/>
              <a:stretch/>
            </p:blipFill>
            <p:spPr>
              <a:xfrm>
                <a:off x="4454280" y="5258520"/>
                <a:ext cx="2065680" cy="1500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0" name="TextBox 17"/>
              <p:cNvSpPr/>
              <p:nvPr/>
            </p:nvSpPr>
            <p:spPr>
              <a:xfrm>
                <a:off x="342720" y="5103000"/>
                <a:ext cx="67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Lipid (ul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Box 18"/>
              <p:cNvSpPr/>
              <p:nvPr/>
            </p:nvSpPr>
            <p:spPr>
              <a:xfrm>
                <a:off x="335160" y="6470280"/>
                <a:ext cx="6728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Lipid (ul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2" name="Picture 2" descr=""/>
            <p:cNvPicPr/>
            <p:nvPr/>
          </p:nvPicPr>
          <p:blipFill>
            <a:blip r:embed="rId8"/>
            <a:stretch/>
          </p:blipFill>
          <p:spPr>
            <a:xfrm>
              <a:off x="1115280" y="6858360"/>
              <a:ext cx="131400" cy="427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19"/>
            <p:cNvSpPr/>
            <p:nvPr/>
          </p:nvSpPr>
          <p:spPr>
            <a:xfrm>
              <a:off x="1195560" y="6810480"/>
              <a:ext cx="4731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elative viability = siNeg transfected with an indicated lipid amount / cells alone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1"/>
            <p:cNvSpPr/>
            <p:nvPr/>
          </p:nvSpPr>
          <p:spPr>
            <a:xfrm>
              <a:off x="1190520" y="7052400"/>
              <a:ext cx="2869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ransfection efficiency =  1- (siCellDeath/siNeg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" name="TextBox 22"/>
          <p:cNvSpPr/>
          <p:nvPr/>
        </p:nvSpPr>
        <p:spPr>
          <a:xfrm>
            <a:off x="154800" y="171360"/>
            <a:ext cx="16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3"/>
          <p:cNvSpPr/>
          <p:nvPr/>
        </p:nvSpPr>
        <p:spPr>
          <a:xfrm>
            <a:off x="366120" y="38088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5"/>
          <p:cNvSpPr/>
          <p:nvPr/>
        </p:nvSpPr>
        <p:spPr>
          <a:xfrm>
            <a:off x="369360" y="3657600"/>
            <a:ext cx="26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"/>
          <p:cNvSpPr/>
          <p:nvPr/>
        </p:nvSpPr>
        <p:spPr>
          <a:xfrm>
            <a:off x="500040" y="7391520"/>
            <a:ext cx="56102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igure S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. Transfection optimization for siRNA screen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. Cell seeding number per well was optimized over a range of seeding concentrations. Viability was measured after 48 hours.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. Transfection efficiency was measured using the indicated concentration of lipid reagent. Cell viability was measured after 48-72 hours. Transfection efficiency is calculated by subtracting the ratio of the average viability of siCellDeath in 8 replicates divided by that of siNeg in 8 replicates from 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05T14:32:25Z</dcterms:created>
  <dc:creator>kimmk2</dc:creator>
  <dc:description/>
  <dc:language>en-US</dc:language>
  <cp:lastModifiedBy>kimmk2</cp:lastModifiedBy>
  <dcterms:modified xsi:type="dcterms:W3CDTF">2016-03-03T22:00:52Z</dcterms:modified>
  <cp:revision>17</cp:revision>
  <dc:subject/>
  <dc:title>PowerPoint Presentation</dc:title>
</cp:coreProperties>
</file>